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BF553C-D541-41BA-8FE2-E652D8DCAD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937E14-A717-4CE4-8FC2-A1C4C5D62C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9235E-28EC-4126-9A03-539656F131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4183F6-55B8-4C1F-A189-FB0F43B064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A2E621-43E1-4AB0-98D9-E8D38CC170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DC599-C70B-4882-84CE-42E56CD46A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35DF2F-43FB-43EE-B4EC-48A4C83C57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481408-180E-4354-A53C-C3CB2C2067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B7715D-ADA7-477C-A41B-B10D3D43C7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B27EC5-CF07-41F7-9A5F-DD135CDB1B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25CDF-2C18-4401-B85F-DE27ECDC85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70966-801C-4CCD-BF0C-C5F3E3C322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740884-AF38-44D5-BB87-10A6A009B818}" type="slidenum">
              <a:rPr b="0" lang="fr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4736520" y="8769240"/>
            <a:ext cx="196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Wacleche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t al.,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Suppl. Figure 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e 53"/>
          <p:cNvGrpSpPr/>
          <p:nvPr/>
        </p:nvGrpSpPr>
        <p:grpSpPr>
          <a:xfrm>
            <a:off x="549360" y="1187280"/>
            <a:ext cx="5726880" cy="6100920"/>
            <a:chOff x="549360" y="1187280"/>
            <a:chExt cx="5726880" cy="6100920"/>
          </a:xfrm>
        </p:grpSpPr>
        <p:grpSp>
          <p:nvGrpSpPr>
            <p:cNvPr id="43" name="Groupe 49"/>
            <p:cNvGrpSpPr/>
            <p:nvPr/>
          </p:nvGrpSpPr>
          <p:grpSpPr>
            <a:xfrm>
              <a:off x="559440" y="1187280"/>
              <a:ext cx="5716800" cy="902880"/>
              <a:chOff x="559440" y="1187280"/>
              <a:chExt cx="5716800" cy="902880"/>
            </a:xfrm>
          </p:grpSpPr>
          <p:sp>
            <p:nvSpPr>
              <p:cNvPr id="44" name="ZoneTexte 25"/>
              <p:cNvSpPr/>
              <p:nvPr/>
            </p:nvSpPr>
            <p:spPr>
              <a:xfrm>
                <a:off x="559440" y="1187280"/>
                <a:ext cx="1688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.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xperimental flow chart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Straight Connector 26"/>
              <p:cNvSpPr/>
              <p:nvPr/>
            </p:nvSpPr>
            <p:spPr>
              <a:xfrm>
                <a:off x="1054440" y="1736280"/>
                <a:ext cx="0" cy="90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Straight Connector 27"/>
              <p:cNvSpPr/>
              <p:nvPr/>
            </p:nvSpPr>
            <p:spPr>
              <a:xfrm flipH="1">
                <a:off x="1052640" y="1736280"/>
                <a:ext cx="4678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Straight Connector 28"/>
              <p:cNvSpPr/>
              <p:nvPr/>
            </p:nvSpPr>
            <p:spPr>
              <a:xfrm>
                <a:off x="2494080" y="1736280"/>
                <a:ext cx="0" cy="90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TextBox 35"/>
              <p:cNvSpPr/>
              <p:nvPr/>
            </p:nvSpPr>
            <p:spPr>
              <a:xfrm>
                <a:off x="794880" y="1458360"/>
                <a:ext cx="511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Day 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Box 36"/>
              <p:cNvSpPr/>
              <p:nvPr/>
            </p:nvSpPr>
            <p:spPr>
              <a:xfrm>
                <a:off x="2237400" y="1458360"/>
                <a:ext cx="511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Day 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Straight Connector 31"/>
              <p:cNvSpPr/>
              <p:nvPr/>
            </p:nvSpPr>
            <p:spPr>
              <a:xfrm>
                <a:off x="5732280" y="1736280"/>
                <a:ext cx="0" cy="90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TextBox 38"/>
              <p:cNvSpPr/>
              <p:nvPr/>
            </p:nvSpPr>
            <p:spPr>
              <a:xfrm>
                <a:off x="5501880" y="1458360"/>
                <a:ext cx="581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Day 13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39"/>
              <p:cNvSpPr/>
              <p:nvPr/>
            </p:nvSpPr>
            <p:spPr>
              <a:xfrm>
                <a:off x="654840" y="1843920"/>
                <a:ext cx="792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D3/CD28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TextBox 41"/>
              <p:cNvSpPr/>
              <p:nvPr/>
            </p:nvSpPr>
            <p:spPr>
              <a:xfrm>
                <a:off x="5211720" y="1843920"/>
                <a:ext cx="1064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PMA/Ionomycin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42"/>
              <p:cNvSpPr/>
              <p:nvPr/>
            </p:nvSpPr>
            <p:spPr>
              <a:xfrm>
                <a:off x="2276640" y="1843920"/>
                <a:ext cx="433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IL-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5" name="Groupe 51"/>
            <p:cNvGrpSpPr/>
            <p:nvPr/>
          </p:nvGrpSpPr>
          <p:grpSpPr>
            <a:xfrm>
              <a:off x="549360" y="5678640"/>
              <a:ext cx="3180240" cy="1609560"/>
              <a:chOff x="549360" y="5678640"/>
              <a:chExt cx="3180240" cy="1609560"/>
            </a:xfrm>
          </p:grpSpPr>
          <p:pic>
            <p:nvPicPr>
              <p:cNvPr id="56" name="Picture 2" descr=""/>
              <p:cNvPicPr/>
              <p:nvPr/>
            </p:nvPicPr>
            <p:blipFill>
              <a:blip r:embed="rId1"/>
              <a:stretch/>
            </p:blipFill>
            <p:spPr>
              <a:xfrm>
                <a:off x="549360" y="5678640"/>
                <a:ext cx="3180240" cy="1609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7" name="ZoneTexte 23"/>
              <p:cNvSpPr/>
              <p:nvPr/>
            </p:nvSpPr>
            <p:spPr>
              <a:xfrm>
                <a:off x="551520" y="5678640"/>
                <a:ext cx="290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58" name="Picture 7" descr=""/>
            <p:cNvPicPr/>
            <p:nvPr/>
          </p:nvPicPr>
          <p:blipFill>
            <a:blip r:embed="rId2"/>
            <a:srcRect l="17277" t="0" r="0" b="36149"/>
            <a:stretch/>
          </p:blipFill>
          <p:spPr>
            <a:xfrm>
              <a:off x="1900800" y="4435920"/>
              <a:ext cx="839880" cy="869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10" descr=""/>
            <p:cNvPicPr/>
            <p:nvPr/>
          </p:nvPicPr>
          <p:blipFill>
            <a:blip r:embed="rId3"/>
            <a:srcRect l="16568" t="0" r="0" b="35686"/>
            <a:stretch/>
          </p:blipFill>
          <p:spPr>
            <a:xfrm>
              <a:off x="2855520" y="4429800"/>
              <a:ext cx="847440" cy="875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14" descr=""/>
            <p:cNvPicPr/>
            <p:nvPr/>
          </p:nvPicPr>
          <p:blipFill>
            <a:blip r:embed="rId4"/>
            <a:srcRect l="16568" t="0" r="0" b="35686"/>
            <a:stretch/>
          </p:blipFill>
          <p:spPr>
            <a:xfrm>
              <a:off x="3742200" y="4429800"/>
              <a:ext cx="847440" cy="875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17" descr=""/>
            <p:cNvPicPr/>
            <p:nvPr/>
          </p:nvPicPr>
          <p:blipFill>
            <a:blip r:embed="rId5"/>
            <a:srcRect l="16568" t="0" r="0" b="35686"/>
            <a:stretch/>
          </p:blipFill>
          <p:spPr>
            <a:xfrm>
              <a:off x="986400" y="4429800"/>
              <a:ext cx="847440" cy="875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31" descr=""/>
            <p:cNvPicPr/>
            <p:nvPr/>
          </p:nvPicPr>
          <p:blipFill>
            <a:blip r:embed="rId6"/>
            <a:srcRect l="17277" t="0" r="0" b="35752"/>
            <a:stretch/>
          </p:blipFill>
          <p:spPr>
            <a:xfrm>
              <a:off x="994320" y="3499920"/>
              <a:ext cx="839880" cy="874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33" descr=""/>
            <p:cNvPicPr/>
            <p:nvPr/>
          </p:nvPicPr>
          <p:blipFill>
            <a:blip r:embed="rId7"/>
            <a:srcRect l="17011" t="0" r="0" b="36149"/>
            <a:stretch/>
          </p:blipFill>
          <p:spPr>
            <a:xfrm>
              <a:off x="1903320" y="3504600"/>
              <a:ext cx="842760" cy="869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34" descr=""/>
            <p:cNvPicPr/>
            <p:nvPr/>
          </p:nvPicPr>
          <p:blipFill>
            <a:blip r:embed="rId8"/>
            <a:srcRect l="17011" t="0" r="0" b="35554"/>
            <a:stretch/>
          </p:blipFill>
          <p:spPr>
            <a:xfrm>
              <a:off x="2867400" y="3493440"/>
              <a:ext cx="842760" cy="877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37" descr=""/>
            <p:cNvPicPr/>
            <p:nvPr/>
          </p:nvPicPr>
          <p:blipFill>
            <a:blip r:embed="rId9"/>
            <a:srcRect l="17011" t="0" r="0" b="35620"/>
            <a:stretch/>
          </p:blipFill>
          <p:spPr>
            <a:xfrm>
              <a:off x="3749040" y="3495240"/>
              <a:ext cx="842760" cy="876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47" descr=""/>
            <p:cNvPicPr/>
            <p:nvPr/>
          </p:nvPicPr>
          <p:blipFill>
            <a:blip r:embed="rId10"/>
            <a:srcRect l="20930" t="5885" r="0" b="37365"/>
            <a:stretch/>
          </p:blipFill>
          <p:spPr>
            <a:xfrm>
              <a:off x="4640400" y="4448880"/>
              <a:ext cx="847440" cy="85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50" descr=""/>
            <p:cNvPicPr/>
            <p:nvPr/>
          </p:nvPicPr>
          <p:blipFill>
            <a:blip r:embed="rId11"/>
            <a:srcRect l="20457" t="6846" r="2073" b="36086"/>
            <a:stretch/>
          </p:blipFill>
          <p:spPr>
            <a:xfrm>
              <a:off x="4631040" y="3523680"/>
              <a:ext cx="842760" cy="867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4" descr=""/>
            <p:cNvPicPr/>
            <p:nvPr/>
          </p:nvPicPr>
          <p:blipFill>
            <a:blip r:embed="rId12"/>
            <a:srcRect l="20737" t="0" r="0" b="34393"/>
            <a:stretch/>
          </p:blipFill>
          <p:spPr>
            <a:xfrm>
              <a:off x="1002240" y="2538720"/>
              <a:ext cx="849960" cy="915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8" descr=""/>
            <p:cNvPicPr/>
            <p:nvPr/>
          </p:nvPicPr>
          <p:blipFill>
            <a:blip r:embed="rId13"/>
            <a:srcRect l="20676" t="0" r="0" b="34714"/>
            <a:stretch/>
          </p:blipFill>
          <p:spPr>
            <a:xfrm>
              <a:off x="1910880" y="2543400"/>
              <a:ext cx="865080" cy="91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10" descr=""/>
            <p:cNvPicPr/>
            <p:nvPr/>
          </p:nvPicPr>
          <p:blipFill>
            <a:blip r:embed="rId14"/>
            <a:srcRect l="19486" t="0" r="10180" b="34467"/>
            <a:stretch/>
          </p:blipFill>
          <p:spPr>
            <a:xfrm>
              <a:off x="2866680" y="2539800"/>
              <a:ext cx="816480" cy="914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14" descr=""/>
            <p:cNvPicPr/>
            <p:nvPr/>
          </p:nvPicPr>
          <p:blipFill>
            <a:blip r:embed="rId15"/>
            <a:srcRect l="20388" t="0" r="9159" b="34566"/>
            <a:stretch/>
          </p:blipFill>
          <p:spPr>
            <a:xfrm>
              <a:off x="3757680" y="2541240"/>
              <a:ext cx="807120" cy="913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16" descr=""/>
            <p:cNvPicPr/>
            <p:nvPr/>
          </p:nvPicPr>
          <p:blipFill>
            <a:blip r:embed="rId16"/>
            <a:srcRect l="20866" t="0" r="0" b="35375"/>
            <a:stretch/>
          </p:blipFill>
          <p:spPr>
            <a:xfrm>
              <a:off x="4638960" y="2544480"/>
              <a:ext cx="848520" cy="902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Line 18"/>
            <p:cNvSpPr/>
            <p:nvPr/>
          </p:nvSpPr>
          <p:spPr>
            <a:xfrm>
              <a:off x="916560" y="5378400"/>
              <a:ext cx="431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Line 19"/>
            <p:cNvSpPr/>
            <p:nvPr/>
          </p:nvSpPr>
          <p:spPr>
            <a:xfrm flipV="1">
              <a:off x="916560" y="2858040"/>
              <a:ext cx="0" cy="2520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 Box 27"/>
            <p:cNvSpPr/>
            <p:nvPr/>
          </p:nvSpPr>
          <p:spPr>
            <a:xfrm>
              <a:off x="3077640" y="5357520"/>
              <a:ext cx="49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FN-γ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 Box 30"/>
            <p:cNvSpPr/>
            <p:nvPr/>
          </p:nvSpPr>
          <p:spPr>
            <a:xfrm rot="16200000">
              <a:off x="510480" y="4721040"/>
              <a:ext cx="55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L-17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ZoneTexte 21"/>
            <p:cNvSpPr/>
            <p:nvPr/>
          </p:nvSpPr>
          <p:spPr>
            <a:xfrm>
              <a:off x="562320" y="2166480"/>
              <a:ext cx="271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.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tracellular cytokine expression – Day 1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Box 21"/>
            <p:cNvSpPr/>
            <p:nvPr/>
          </p:nvSpPr>
          <p:spPr>
            <a:xfrm>
              <a:off x="5448960" y="2926440"/>
              <a:ext cx="816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I on ART 0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33"/>
            <p:cNvSpPr/>
            <p:nvPr/>
          </p:nvSpPr>
          <p:spPr>
            <a:xfrm>
              <a:off x="5448960" y="3853080"/>
              <a:ext cx="816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I on ART 0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34"/>
            <p:cNvSpPr/>
            <p:nvPr/>
          </p:nvSpPr>
          <p:spPr>
            <a:xfrm>
              <a:off x="5448960" y="4730040"/>
              <a:ext cx="816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I on ART 0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 Box 6"/>
            <p:cNvSpPr/>
            <p:nvPr/>
          </p:nvSpPr>
          <p:spPr>
            <a:xfrm>
              <a:off x="1222560" y="2424960"/>
              <a:ext cx="41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h1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 Box 9"/>
            <p:cNvSpPr/>
            <p:nvPr/>
          </p:nvSpPr>
          <p:spPr>
            <a:xfrm>
              <a:off x="2042280" y="2424960"/>
              <a:ext cx="599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h1Th1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 Box 13"/>
            <p:cNvSpPr/>
            <p:nvPr/>
          </p:nvSpPr>
          <p:spPr>
            <a:xfrm>
              <a:off x="2954520" y="2424960"/>
              <a:ext cx="66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  <a:ea typeface="ＭＳ Ｐゴシック"/>
                </a:rPr>
                <a:t>CCR6+D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 Box 15"/>
            <p:cNvSpPr/>
            <p:nvPr/>
          </p:nvSpPr>
          <p:spPr>
            <a:xfrm>
              <a:off x="3831480" y="2424960"/>
              <a:ext cx="657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CR6+DP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 Box 6"/>
            <p:cNvSpPr/>
            <p:nvPr/>
          </p:nvSpPr>
          <p:spPr>
            <a:xfrm>
              <a:off x="4859640" y="242496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h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19T20:51:22Z</dcterms:created>
  <dc:creator>p0029576</dc:creator>
  <dc:description/>
  <dc:language>en-US</dc:language>
  <cp:lastModifiedBy>sspira</cp:lastModifiedBy>
  <dcterms:modified xsi:type="dcterms:W3CDTF">2016-08-10T23:56:14Z</dcterms:modified>
  <cp:revision>17</cp:revision>
  <dc:subject/>
  <dc:title>Présentation PowerPoint</dc:title>
</cp:coreProperties>
</file>